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7" d="100"/>
          <a:sy n="117" d="100"/>
        </p:scale>
        <p:origin x="216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E043F-DD1F-43B9-B632-45858B73D17D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051C5-332F-4063-8C15-17567E777C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33208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E043F-DD1F-43B9-B632-45858B73D17D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051C5-332F-4063-8C15-17567E777C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18651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E043F-DD1F-43B9-B632-45858B73D17D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051C5-332F-4063-8C15-17567E777C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7112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E043F-DD1F-43B9-B632-45858B73D17D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051C5-332F-4063-8C15-17567E777C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28022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E043F-DD1F-43B9-B632-45858B73D17D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051C5-332F-4063-8C15-17567E777C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26960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E043F-DD1F-43B9-B632-45858B73D17D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051C5-332F-4063-8C15-17567E777C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6878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E043F-DD1F-43B9-B632-45858B73D17D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051C5-332F-4063-8C15-17567E777C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8416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E043F-DD1F-43B9-B632-45858B73D17D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051C5-332F-4063-8C15-17567E777C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9673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E043F-DD1F-43B9-B632-45858B73D17D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051C5-332F-4063-8C15-17567E777C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95497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E043F-DD1F-43B9-B632-45858B73D17D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051C5-332F-4063-8C15-17567E777C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6247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AE043F-DD1F-43B9-B632-45858B73D17D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051C5-332F-4063-8C15-17567E777C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83866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AE043F-DD1F-43B9-B632-45858B73D17D}" type="datetimeFigureOut">
              <a:rPr lang="en-GB" smtClean="0"/>
              <a:t>14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E051C5-332F-4063-8C15-17567E777C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40300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1575704" y="164021"/>
            <a:ext cx="88265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ementary Figure S1. </a:t>
            </a:r>
            <a:r>
              <a:rPr lang="en-GB" sz="1200" dirty="0" smtClean="0"/>
              <a:t>Images of the four replicates of p226/135/16 sampled at each estimated water content (EWC) point for </a:t>
            </a:r>
            <a:r>
              <a:rPr lang="en-GB" sz="1200" dirty="0" err="1" smtClean="0"/>
              <a:t>RNAseq</a:t>
            </a:r>
            <a:r>
              <a:rPr lang="en-GB" sz="1200" dirty="0" smtClean="0"/>
              <a:t>. </a:t>
            </a:r>
            <a:endParaRPr lang="en-GB" sz="1200" b="1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13916" y="629480"/>
            <a:ext cx="7888908" cy="59745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65950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0</TotalTime>
  <Words>2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xx</dc:creator>
  <cp:lastModifiedBy>xxx</cp:lastModifiedBy>
  <cp:revision>5</cp:revision>
  <dcterms:created xsi:type="dcterms:W3CDTF">2019-05-09T09:03:36Z</dcterms:created>
  <dcterms:modified xsi:type="dcterms:W3CDTF">2019-05-14T10:36:08Z</dcterms:modified>
</cp:coreProperties>
</file>